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859088" cy="2859088"/>
  <p:notesSz cx="6858000" cy="9144000"/>
  <p:defaultTextStyle>
    <a:defPPr>
      <a:defRPr lang="ja-JP"/>
    </a:defPPr>
    <a:lvl1pPr marL="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1pPr>
    <a:lvl2pPr marL="16335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2pPr>
    <a:lvl3pPr marL="32671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3pPr>
    <a:lvl4pPr marL="49007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4pPr>
    <a:lvl5pPr marL="65343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5pPr>
    <a:lvl6pPr marL="81678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6pPr>
    <a:lvl7pPr marL="98014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7pPr>
    <a:lvl8pPr marL="114350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8pPr>
    <a:lvl9pPr marL="130686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01">
          <p15:clr>
            <a:srgbClr val="A4A3A4"/>
          </p15:clr>
        </p15:guide>
        <p15:guide id="2" pos="9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0" d="100"/>
          <a:sy n="300" d="100"/>
        </p:scale>
        <p:origin x="4416" y="786"/>
      </p:cViewPr>
      <p:guideLst>
        <p:guide orient="horz" pos="901"/>
        <p:guide pos="9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9.8&#20316;&#35069;&#12476;&#12494;&#12464;&#12521;&#12501;&#12488;)RPC-9%20&#9312;afa(10).bev(5)%20&#9313;afa(25).cet(1)%20&#9314;gef.cet.bev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(2014.9.8&#20316;&#35069;&#12476;&#12494;&#12464;&#12521;&#12501;&#12488;)RPC-9%20&#9312;afa(10).bev(5)%20&#9313;afa(25).cet(1)%20&#9314;gef.cet.bev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1291733890441054E-2"/>
          <c:y val="0.14235477418375281"/>
          <c:w val="0.80457932524620912"/>
          <c:h val="0.6054398477201327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99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26:$U$226</c:f>
                <c:numCache>
                  <c:formatCode>General</c:formatCode>
                  <c:ptCount val="17"/>
                  <c:pt idx="0">
                    <c:v>0.4425306015783918</c:v>
                  </c:pt>
                  <c:pt idx="1">
                    <c:v>0.29261749776799034</c:v>
                  </c:pt>
                  <c:pt idx="2">
                    <c:v>0.40926763859362247</c:v>
                  </c:pt>
                  <c:pt idx="3">
                    <c:v>0.37969285832981781</c:v>
                  </c:pt>
                  <c:pt idx="4">
                    <c:v>0.1040832999733067</c:v>
                  </c:pt>
                  <c:pt idx="5">
                    <c:v>0.25617376914898971</c:v>
                  </c:pt>
                  <c:pt idx="6">
                    <c:v>0.39660013447635983</c:v>
                  </c:pt>
                  <c:pt idx="7">
                    <c:v>0.50723925978443951</c:v>
                  </c:pt>
                  <c:pt idx="8">
                    <c:v>0.70872538170060373</c:v>
                  </c:pt>
                  <c:pt idx="9">
                    <c:v>0.52816506258302698</c:v>
                  </c:pt>
                  <c:pt idx="10">
                    <c:v>0.42914643965279137</c:v>
                  </c:pt>
                  <c:pt idx="11">
                    <c:v>0.63031076991168955</c:v>
                  </c:pt>
                  <c:pt idx="12">
                    <c:v>0.83765545820860432</c:v>
                  </c:pt>
                  <c:pt idx="13">
                    <c:v>0.54848275573014482</c:v>
                  </c:pt>
                  <c:pt idx="14">
                    <c:v>0.57500000000000029</c:v>
                  </c:pt>
                  <c:pt idx="15">
                    <c:v>0.56770737767503665</c:v>
                  </c:pt>
                  <c:pt idx="16">
                    <c:v>0.65748890991914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98:$U$298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99:$U$299</c:f>
              <c:numCache>
                <c:formatCode>General</c:formatCode>
                <c:ptCount val="17"/>
                <c:pt idx="0">
                  <c:v>19.25</c:v>
                </c:pt>
                <c:pt idx="1">
                  <c:v>19.475000000000001</c:v>
                </c:pt>
                <c:pt idx="2">
                  <c:v>19.049999999999997</c:v>
                </c:pt>
                <c:pt idx="3">
                  <c:v>19.850000000000001</c:v>
                </c:pt>
                <c:pt idx="4">
                  <c:v>20.95</c:v>
                </c:pt>
                <c:pt idx="5">
                  <c:v>20.325000000000003</c:v>
                </c:pt>
                <c:pt idx="6">
                  <c:v>20.224999999999998</c:v>
                </c:pt>
                <c:pt idx="7">
                  <c:v>20.075000000000003</c:v>
                </c:pt>
                <c:pt idx="8">
                  <c:v>20.274999999999999</c:v>
                </c:pt>
                <c:pt idx="9">
                  <c:v>20.975000000000001</c:v>
                </c:pt>
                <c:pt idx="10">
                  <c:v>20.549999999999997</c:v>
                </c:pt>
                <c:pt idx="11">
                  <c:v>21.125</c:v>
                </c:pt>
                <c:pt idx="12">
                  <c:v>20.700000000000003</c:v>
                </c:pt>
                <c:pt idx="13">
                  <c:v>21.150000000000002</c:v>
                </c:pt>
                <c:pt idx="14">
                  <c:v>20.675000000000001</c:v>
                </c:pt>
                <c:pt idx="15">
                  <c:v>20.425000000000001</c:v>
                </c:pt>
                <c:pt idx="16">
                  <c:v>20.22499999999999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300</c:f>
              <c:strCache>
                <c:ptCount val="1"/>
                <c:pt idx="0">
                  <c:v>Afa(25)/cet(1)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ysDash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45:$U$245</c:f>
                <c:numCache>
                  <c:formatCode>General</c:formatCode>
                  <c:ptCount val="17"/>
                  <c:pt idx="0">
                    <c:v>0.44791182167922305</c:v>
                  </c:pt>
                  <c:pt idx="1">
                    <c:v>0.47675115801292645</c:v>
                  </c:pt>
                  <c:pt idx="2">
                    <c:v>0.4714781719938545</c:v>
                  </c:pt>
                  <c:pt idx="3">
                    <c:v>0.52041649986653249</c:v>
                  </c:pt>
                  <c:pt idx="4">
                    <c:v>0.4377975178854569</c:v>
                  </c:pt>
                  <c:pt idx="5">
                    <c:v>0.75869954527467598</c:v>
                  </c:pt>
                  <c:pt idx="6">
                    <c:v>0.98742088290657493</c:v>
                  </c:pt>
                  <c:pt idx="7">
                    <c:v>0.86554414483991893</c:v>
                  </c:pt>
                  <c:pt idx="8">
                    <c:v>0.55452682532047104</c:v>
                  </c:pt>
                  <c:pt idx="9">
                    <c:v>0.42622372841814737</c:v>
                  </c:pt>
                  <c:pt idx="10">
                    <c:v>0.67623344095561144</c:v>
                  </c:pt>
                  <c:pt idx="11">
                    <c:v>0.73527205849263733</c:v>
                  </c:pt>
                  <c:pt idx="12">
                    <c:v>0.74049532971743515</c:v>
                  </c:pt>
                  <c:pt idx="13">
                    <c:v>0.94725480556535924</c:v>
                  </c:pt>
                  <c:pt idx="14">
                    <c:v>0.91012819609840301</c:v>
                  </c:pt>
                  <c:pt idx="15">
                    <c:v>0.84360338232291776</c:v>
                  </c:pt>
                  <c:pt idx="16">
                    <c:v>0.673918887305191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98:$U$298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300:$U$300</c:f>
              <c:numCache>
                <c:formatCode>General</c:formatCode>
                <c:ptCount val="17"/>
                <c:pt idx="0">
                  <c:v>18.175000000000001</c:v>
                </c:pt>
                <c:pt idx="1">
                  <c:v>19.024999999999999</c:v>
                </c:pt>
                <c:pt idx="2">
                  <c:v>17.324999999999999</c:v>
                </c:pt>
                <c:pt idx="3">
                  <c:v>16.95</c:v>
                </c:pt>
                <c:pt idx="4">
                  <c:v>17.100000000000001</c:v>
                </c:pt>
                <c:pt idx="5">
                  <c:v>17.725000000000001</c:v>
                </c:pt>
                <c:pt idx="6">
                  <c:v>17.900000000000002</c:v>
                </c:pt>
                <c:pt idx="7">
                  <c:v>17.850000000000001</c:v>
                </c:pt>
                <c:pt idx="8">
                  <c:v>17.350000000000001</c:v>
                </c:pt>
                <c:pt idx="9">
                  <c:v>19.2</c:v>
                </c:pt>
                <c:pt idx="10">
                  <c:v>19.774999999999999</c:v>
                </c:pt>
                <c:pt idx="11">
                  <c:v>21.824999999999999</c:v>
                </c:pt>
                <c:pt idx="12">
                  <c:v>21.75</c:v>
                </c:pt>
                <c:pt idx="13">
                  <c:v>21.974999999999998</c:v>
                </c:pt>
                <c:pt idx="14">
                  <c:v>22.45</c:v>
                </c:pt>
                <c:pt idx="15">
                  <c:v>22.725000000000001</c:v>
                </c:pt>
                <c:pt idx="16">
                  <c:v>23.800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63644352"/>
        <c:axId val="-563649792"/>
      </c:scatterChart>
      <c:valAx>
        <c:axId val="-563644352"/>
        <c:scaling>
          <c:orientation val="minMax"/>
          <c:max val="56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6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563649792"/>
        <c:crosses val="autoZero"/>
        <c:crossBetween val="midCat"/>
        <c:majorUnit val="7"/>
      </c:valAx>
      <c:valAx>
        <c:axId val="-563649792"/>
        <c:scaling>
          <c:orientation val="minMax"/>
          <c:max val="25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5636443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7702931576400993"/>
          <c:y val="0.53198434988906129"/>
          <c:w val="0.34111805508354826"/>
          <c:h val="0.16722943083025252"/>
        </c:manualLayout>
      </c:layout>
      <c:overlay val="0"/>
      <c:txPr>
        <a:bodyPr/>
        <a:lstStyle/>
        <a:p>
          <a:pPr>
            <a:defRPr sz="600" b="1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7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045835662381221E-2"/>
          <c:y val="0.11260280950861004"/>
          <c:w val="0.86959308386083123"/>
          <c:h val="0.70687481662749352"/>
        </c:manualLayout>
      </c:layout>
      <c:scatterChart>
        <c:scatterStyle val="lineMarker"/>
        <c:varyColors val="0"/>
        <c:ser>
          <c:idx val="0"/>
          <c:order val="0"/>
          <c:tx>
            <c:strRef>
              <c:f>'RPC-9'!$D$294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26:$U$226</c:f>
                <c:numCache>
                  <c:formatCode>General</c:formatCode>
                  <c:ptCount val="17"/>
                  <c:pt idx="0">
                    <c:v>0.4425306015783918</c:v>
                  </c:pt>
                  <c:pt idx="1">
                    <c:v>0.29261749776799034</c:v>
                  </c:pt>
                  <c:pt idx="2">
                    <c:v>0.40926763859362247</c:v>
                  </c:pt>
                  <c:pt idx="3">
                    <c:v>0.37969285832981781</c:v>
                  </c:pt>
                  <c:pt idx="4">
                    <c:v>0.1040832999733067</c:v>
                  </c:pt>
                  <c:pt idx="5">
                    <c:v>0.25617376914898971</c:v>
                  </c:pt>
                  <c:pt idx="6">
                    <c:v>0.39660013447635983</c:v>
                  </c:pt>
                  <c:pt idx="7">
                    <c:v>0.50723925978443951</c:v>
                  </c:pt>
                  <c:pt idx="8">
                    <c:v>0.70872538170060373</c:v>
                  </c:pt>
                  <c:pt idx="9">
                    <c:v>0.52816506258302698</c:v>
                  </c:pt>
                  <c:pt idx="10">
                    <c:v>0.42914643965279137</c:v>
                  </c:pt>
                  <c:pt idx="11">
                    <c:v>0.63031076991168955</c:v>
                  </c:pt>
                  <c:pt idx="12">
                    <c:v>0.83765545820860432</c:v>
                  </c:pt>
                  <c:pt idx="13">
                    <c:v>0.54848275573014482</c:v>
                  </c:pt>
                  <c:pt idx="14">
                    <c:v>0.57500000000000029</c:v>
                  </c:pt>
                  <c:pt idx="15">
                    <c:v>0.56770737767503665</c:v>
                  </c:pt>
                  <c:pt idx="16">
                    <c:v>0.65748890991914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93:$U$293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94:$U$294</c:f>
              <c:numCache>
                <c:formatCode>General</c:formatCode>
                <c:ptCount val="17"/>
                <c:pt idx="0">
                  <c:v>19.25</c:v>
                </c:pt>
                <c:pt idx="1">
                  <c:v>19.475000000000001</c:v>
                </c:pt>
                <c:pt idx="2">
                  <c:v>19.049999999999997</c:v>
                </c:pt>
                <c:pt idx="3">
                  <c:v>19.850000000000001</c:v>
                </c:pt>
                <c:pt idx="4">
                  <c:v>20.95</c:v>
                </c:pt>
                <c:pt idx="5">
                  <c:v>20.325000000000003</c:v>
                </c:pt>
                <c:pt idx="6">
                  <c:v>20.224999999999998</c:v>
                </c:pt>
                <c:pt idx="7">
                  <c:v>20.075000000000003</c:v>
                </c:pt>
                <c:pt idx="8">
                  <c:v>20.274999999999999</c:v>
                </c:pt>
                <c:pt idx="9">
                  <c:v>20.975000000000001</c:v>
                </c:pt>
                <c:pt idx="10">
                  <c:v>20.549999999999997</c:v>
                </c:pt>
                <c:pt idx="11">
                  <c:v>21.125</c:v>
                </c:pt>
                <c:pt idx="12">
                  <c:v>20.700000000000003</c:v>
                </c:pt>
                <c:pt idx="13">
                  <c:v>21.150000000000002</c:v>
                </c:pt>
                <c:pt idx="14">
                  <c:v>20.675000000000001</c:v>
                </c:pt>
                <c:pt idx="15">
                  <c:v>20.425000000000001</c:v>
                </c:pt>
                <c:pt idx="16">
                  <c:v>20.22499999999999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PC-9'!$D$295</c:f>
              <c:strCache>
                <c:ptCount val="1"/>
                <c:pt idx="0">
                  <c:v>Afa(10)/bev(5)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ash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'RPC-9'!$E$236:$U$236</c:f>
                <c:numCache>
                  <c:formatCode>General</c:formatCode>
                  <c:ptCount val="17"/>
                  <c:pt idx="0">
                    <c:v>0.60553007081949795</c:v>
                  </c:pt>
                  <c:pt idx="1">
                    <c:v>0.64726990763771242</c:v>
                  </c:pt>
                  <c:pt idx="2">
                    <c:v>0.5700877125495688</c:v>
                  </c:pt>
                  <c:pt idx="3">
                    <c:v>0.17320508075688712</c:v>
                  </c:pt>
                  <c:pt idx="4">
                    <c:v>0.35707142142714249</c:v>
                  </c:pt>
                  <c:pt idx="5">
                    <c:v>0.20564937798755117</c:v>
                  </c:pt>
                  <c:pt idx="6">
                    <c:v>0.29011491975881987</c:v>
                  </c:pt>
                  <c:pt idx="7">
                    <c:v>0.32755406678389198</c:v>
                  </c:pt>
                  <c:pt idx="8">
                    <c:v>0.53599595769619979</c:v>
                  </c:pt>
                  <c:pt idx="9">
                    <c:v>0.35939764421413084</c:v>
                  </c:pt>
                  <c:pt idx="10">
                    <c:v>0.34034296427770266</c:v>
                  </c:pt>
                  <c:pt idx="11">
                    <c:v>0.47324236215002285</c:v>
                  </c:pt>
                  <c:pt idx="12">
                    <c:v>0.22730302828309781</c:v>
                  </c:pt>
                  <c:pt idx="13">
                    <c:v>0.44440972086577968</c:v>
                  </c:pt>
                  <c:pt idx="14">
                    <c:v>0.82600948339995894</c:v>
                  </c:pt>
                  <c:pt idx="15">
                    <c:v>0.76919871728095501</c:v>
                  </c:pt>
                  <c:pt idx="16">
                    <c:v>0.781558272512890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'RPC-9'!$E$293:$U$293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'RPC-9'!$E$295:$U$295</c:f>
              <c:numCache>
                <c:formatCode>General</c:formatCode>
                <c:ptCount val="17"/>
                <c:pt idx="0">
                  <c:v>18.899999999999999</c:v>
                </c:pt>
                <c:pt idx="1">
                  <c:v>18.425000000000001</c:v>
                </c:pt>
                <c:pt idx="2">
                  <c:v>18.100000000000001</c:v>
                </c:pt>
                <c:pt idx="3">
                  <c:v>18</c:v>
                </c:pt>
                <c:pt idx="4">
                  <c:v>17.8</c:v>
                </c:pt>
                <c:pt idx="5">
                  <c:v>17.899999999999999</c:v>
                </c:pt>
                <c:pt idx="6">
                  <c:v>17.7</c:v>
                </c:pt>
                <c:pt idx="7">
                  <c:v>17.850000000000001</c:v>
                </c:pt>
                <c:pt idx="8">
                  <c:v>17.7</c:v>
                </c:pt>
                <c:pt idx="9">
                  <c:v>18.849999999999998</c:v>
                </c:pt>
                <c:pt idx="10">
                  <c:v>19.149999999999999</c:v>
                </c:pt>
                <c:pt idx="11">
                  <c:v>18.674999999999997</c:v>
                </c:pt>
                <c:pt idx="12">
                  <c:v>18.7</c:v>
                </c:pt>
                <c:pt idx="13">
                  <c:v>18.849999999999998</c:v>
                </c:pt>
                <c:pt idx="14">
                  <c:v>18.975000000000001</c:v>
                </c:pt>
                <c:pt idx="15">
                  <c:v>19.3</c:v>
                </c:pt>
                <c:pt idx="16">
                  <c:v>19.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63648160"/>
        <c:axId val="-563647616"/>
      </c:scatterChart>
      <c:valAx>
        <c:axId val="-563648160"/>
        <c:scaling>
          <c:orientation val="minMax"/>
          <c:max val="56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6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563647616"/>
        <c:crosses val="autoZero"/>
        <c:crossBetween val="midCat"/>
        <c:majorUnit val="7"/>
      </c:valAx>
      <c:valAx>
        <c:axId val="-563647616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 b="1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ja-JP"/>
          </a:p>
        </c:txPr>
        <c:crossAx val="-5636481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9180540238393787"/>
          <c:y val="0.55884282678995745"/>
          <c:w val="0.34772294653513214"/>
          <c:h val="0.15870306066849149"/>
        </c:manualLayout>
      </c:layout>
      <c:overlay val="0"/>
      <c:txPr>
        <a:bodyPr/>
        <a:lstStyle/>
        <a:p>
          <a:pPr>
            <a:defRPr b="1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6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14432" y="888171"/>
            <a:ext cx="2430225" cy="61285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28863" y="1620150"/>
            <a:ext cx="2001362" cy="73065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3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26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900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53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16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980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43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0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72839" y="114496"/>
            <a:ext cx="643295" cy="243949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2954" y="114496"/>
            <a:ext cx="1882233" cy="243949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25848" y="1837229"/>
            <a:ext cx="2430225" cy="567847"/>
          </a:xfrm>
        </p:spPr>
        <p:txBody>
          <a:bodyPr anchor="t"/>
          <a:lstStyle>
            <a:lvl1pPr algn="l">
              <a:defRPr sz="14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25848" y="1211804"/>
            <a:ext cx="2430225" cy="625425"/>
          </a:xfrm>
        </p:spPr>
        <p:txBody>
          <a:bodyPr anchor="b"/>
          <a:lstStyle>
            <a:lvl1pPr marL="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1pPr>
            <a:lvl2pPr marL="16335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2pPr>
            <a:lvl3pPr marL="326715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49007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4pPr>
            <a:lvl5pPr marL="65343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5pPr>
            <a:lvl6pPr marL="816788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6pPr>
            <a:lvl7pPr marL="980145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7pPr>
            <a:lvl8pPr marL="114350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8pPr>
            <a:lvl9pPr marL="130686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2954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53370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39986"/>
            <a:ext cx="1263260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2955" y="906701"/>
            <a:ext cx="1263260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452377" y="639986"/>
            <a:ext cx="1263757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452377" y="906701"/>
            <a:ext cx="1263757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2955" y="113834"/>
            <a:ext cx="940620" cy="484457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117824" y="113834"/>
            <a:ext cx="1598310" cy="2440152"/>
          </a:xfrm>
        </p:spPr>
        <p:txBody>
          <a:bodyPr/>
          <a:lstStyle>
            <a:lvl1pPr>
              <a:defRPr sz="1100"/>
            </a:lvl1pPr>
            <a:lvl2pPr>
              <a:defRPr sz="1000"/>
            </a:lvl2pPr>
            <a:lvl3pPr>
              <a:defRPr sz="9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2955" y="598291"/>
            <a:ext cx="940620" cy="195569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0401" y="2001362"/>
            <a:ext cx="1715453" cy="236272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560401" y="255465"/>
            <a:ext cx="1715453" cy="1715453"/>
          </a:xfrm>
        </p:spPr>
        <p:txBody>
          <a:bodyPr/>
          <a:lstStyle>
            <a:lvl1pPr marL="0" indent="0">
              <a:buNone/>
              <a:defRPr sz="1100"/>
            </a:lvl1pPr>
            <a:lvl2pPr marL="163358" indent="0">
              <a:buNone/>
              <a:defRPr sz="1000"/>
            </a:lvl2pPr>
            <a:lvl3pPr marL="326715" indent="0">
              <a:buNone/>
              <a:defRPr sz="900"/>
            </a:lvl3pPr>
            <a:lvl4pPr marL="490073" indent="0">
              <a:buNone/>
              <a:defRPr sz="700"/>
            </a:lvl4pPr>
            <a:lvl5pPr marL="653430" indent="0">
              <a:buNone/>
              <a:defRPr sz="700"/>
            </a:lvl5pPr>
            <a:lvl6pPr marL="816788" indent="0">
              <a:buNone/>
              <a:defRPr sz="700"/>
            </a:lvl6pPr>
            <a:lvl7pPr marL="980145" indent="0">
              <a:buNone/>
              <a:defRPr sz="700"/>
            </a:lvl7pPr>
            <a:lvl8pPr marL="1143503" indent="0">
              <a:buNone/>
              <a:defRPr sz="700"/>
            </a:lvl8pPr>
            <a:lvl9pPr marL="1306860" indent="0">
              <a:buNone/>
              <a:defRPr sz="7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60401" y="2237633"/>
            <a:ext cx="1715453" cy="33554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42955" y="114496"/>
            <a:ext cx="2573179" cy="476515"/>
          </a:xfrm>
          <a:prstGeom prst="rect">
            <a:avLst/>
          </a:prstGeom>
        </p:spPr>
        <p:txBody>
          <a:bodyPr vert="horz" lIns="32672" tIns="16336" rIns="32672" bIns="16336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67121"/>
            <a:ext cx="2573179" cy="1886866"/>
          </a:xfrm>
          <a:prstGeom prst="rect">
            <a:avLst/>
          </a:prstGeom>
        </p:spPr>
        <p:txBody>
          <a:bodyPr vert="horz" lIns="32672" tIns="16336" rIns="32672" bIns="1633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42954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976855" y="2649951"/>
            <a:ext cx="905378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2049013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26715" rtl="0" eaLnBrk="1" latinLnBrk="0" hangingPunct="1">
        <a:spcBef>
          <a:spcPct val="0"/>
        </a:spcBef>
        <a:buNone/>
        <a:defRPr kumimoji="1" sz="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2518" indent="-122518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65456" indent="-102098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40839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571751" indent="-81679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35109" indent="-81679" algn="l" defTabSz="326715" rtl="0" eaLnBrk="1" latinLnBrk="0" hangingPunct="1">
        <a:spcBef>
          <a:spcPct val="20000"/>
        </a:spcBef>
        <a:buFont typeface="Arial" pitchFamily="34" charset="0"/>
        <a:buChar char="»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898467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06182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25182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388539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1pPr>
      <a:lvl2pPr marL="16335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32671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3pPr>
      <a:lvl4pPr marL="49007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4pPr>
      <a:lvl5pPr marL="65343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5pPr>
      <a:lvl6pPr marL="81678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6pPr>
      <a:lvl7pPr marL="98014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7pPr>
      <a:lvl8pPr marL="114350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8pPr>
      <a:lvl9pPr marL="130686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4024476"/>
              </p:ext>
            </p:extLst>
          </p:nvPr>
        </p:nvGraphicFramePr>
        <p:xfrm>
          <a:off x="124266" y="61392"/>
          <a:ext cx="2795390" cy="1295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>
            <a:spLocks noChangeArrowheads="1"/>
          </p:cNvSpPr>
          <p:nvPr/>
        </p:nvSpPr>
        <p:spPr bwMode="auto">
          <a:xfrm rot="16200000">
            <a:off x="-297010" y="589963"/>
            <a:ext cx="777995" cy="183973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8" name="左右矢印 7"/>
          <p:cNvSpPr/>
          <p:nvPr/>
        </p:nvSpPr>
        <p:spPr>
          <a:xfrm>
            <a:off x="394116" y="1212746"/>
            <a:ext cx="1107436" cy="60608"/>
          </a:xfrm>
          <a:prstGeom prst="leftRight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68312" y="1239970"/>
            <a:ext cx="8255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右大かっこ 9"/>
          <p:cNvSpPr/>
          <p:nvPr/>
        </p:nvSpPr>
        <p:spPr>
          <a:xfrm>
            <a:off x="1517942" y="343911"/>
            <a:ext cx="45719" cy="16153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1483293" y="199299"/>
            <a:ext cx="193165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b="1" dirty="0">
                <a:latin typeface="Helvetica" panose="020B0604020202020204" pitchFamily="34" charset="0"/>
                <a:cs typeface="Helvetica" panose="020B0604020202020204" pitchFamily="34" charset="0"/>
              </a:rPr>
              <a:t>*　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-10616" y="131398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2088353" y="775429"/>
            <a:ext cx="623704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　</a:t>
            </a:r>
            <a:r>
              <a:rPr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&lt;0.05</a:t>
            </a:r>
            <a:endParaRPr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-10616" y="1429544"/>
            <a:ext cx="269764" cy="246161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313681" y="2566646"/>
            <a:ext cx="462582" cy="184605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左右矢印 16"/>
          <p:cNvSpPr/>
          <p:nvPr/>
        </p:nvSpPr>
        <p:spPr>
          <a:xfrm>
            <a:off x="378002" y="2658949"/>
            <a:ext cx="1107436" cy="60608"/>
          </a:xfrm>
          <a:prstGeom prst="left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42672" y="2686173"/>
            <a:ext cx="8255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2062713" y="2221632"/>
            <a:ext cx="623704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　</a:t>
            </a:r>
            <a:r>
              <a:rPr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&lt;0.05</a:t>
            </a:r>
            <a:endParaRPr lang="ja-JP" alt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右大かっこ 19"/>
          <p:cNvSpPr/>
          <p:nvPr/>
        </p:nvSpPr>
        <p:spPr>
          <a:xfrm>
            <a:off x="1562298" y="1669973"/>
            <a:ext cx="45719" cy="20397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1505877" y="1513908"/>
            <a:ext cx="193165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ja-JP" altLang="en-US" b="1" dirty="0">
                <a:latin typeface="Helvetica" panose="020B0604020202020204" pitchFamily="34" charset="0"/>
                <a:cs typeface="Helvetica" panose="020B0604020202020204" pitchFamily="34" charset="0"/>
              </a:rPr>
              <a:t>*　</a:t>
            </a:r>
          </a:p>
        </p:txBody>
      </p:sp>
      <p:sp>
        <p:nvSpPr>
          <p:cNvPr id="22" name="テキスト ボックス 21"/>
          <p:cNvSpPr txBox="1">
            <a:spLocks noChangeArrowheads="1"/>
          </p:cNvSpPr>
          <p:nvPr/>
        </p:nvSpPr>
        <p:spPr bwMode="auto">
          <a:xfrm rot="16200000">
            <a:off x="-287575" y="1913477"/>
            <a:ext cx="777995" cy="183973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8443217"/>
              </p:ext>
            </p:extLst>
          </p:nvPr>
        </p:nvGraphicFramePr>
        <p:xfrm>
          <a:off x="128543" y="1439070"/>
          <a:ext cx="2647720" cy="1240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5" name="テキスト ボックス 2"/>
          <p:cNvSpPr txBox="1"/>
          <p:nvPr/>
        </p:nvSpPr>
        <p:spPr>
          <a:xfrm>
            <a:off x="-82624" y="-10616"/>
            <a:ext cx="7682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448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8969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9345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57937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22421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86906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5139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315873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b="1" smtClean="0">
                <a:latin typeface="Helvetica" panose="020B0604020202020204" pitchFamily="34" charset="0"/>
                <a:cs typeface="Helvetica" panose="020B0604020202020204" pitchFamily="34" charset="0"/>
              </a:rPr>
              <a:t>Supp </a:t>
            </a:r>
            <a:r>
              <a:rPr kumimoji="1" lang="en-US" altLang="ja-JP" sz="7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igure1</a:t>
            </a:r>
            <a:endParaRPr kumimoji="1" lang="ja-JP" altLang="en-U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288617" y="1157400"/>
            <a:ext cx="462582" cy="184605"/>
          </a:xfrm>
          <a:prstGeom prst="rect">
            <a:avLst/>
          </a:prstGeom>
          <a:noFill/>
        </p:spPr>
        <p:txBody>
          <a:bodyPr wrap="square" lIns="91379" tIns="45690" rIns="91379" bIns="45690" rtlCol="0">
            <a:spAutoFit/>
          </a:bodyPr>
          <a:lstStyle/>
          <a:p>
            <a:r>
              <a:rPr lang="en-US" altLang="ja-JP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085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8</Words>
  <Application>Microsoft Office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ichiro</dc:creator>
  <cp:lastModifiedBy>kadoaki</cp:lastModifiedBy>
  <cp:revision>19</cp:revision>
  <dcterms:created xsi:type="dcterms:W3CDTF">2016-08-27T14:04:12Z</dcterms:created>
  <dcterms:modified xsi:type="dcterms:W3CDTF">2017-03-26T02:42:00Z</dcterms:modified>
</cp:coreProperties>
</file>